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菊谷 知也" initials="菊谷" lastIdx="1" clrIdx="0">
    <p:extLst>
      <p:ext uri="{19B8F6BF-5375-455C-9EA6-DF929625EA0E}">
        <p15:presenceInfo xmlns:p15="http://schemas.microsoft.com/office/powerpoint/2012/main" userId="e2983a82ba73b33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  <a:srgbClr val="0096FF"/>
    <a:srgbClr val="67BE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13" autoAdjust="0"/>
    <p:restoredTop sz="94660"/>
  </p:normalViewPr>
  <p:slideViewPr>
    <p:cSldViewPr snapToGrid="0">
      <p:cViewPr varScale="1">
        <p:scale>
          <a:sx n="99" d="100"/>
          <a:sy n="99" d="100"/>
        </p:scale>
        <p:origin x="336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819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401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1874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156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221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766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921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828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776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687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6139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69FE9-0A4E-4927-8FAE-0C2C497DB95E}" type="datetimeFigureOut">
              <a:rPr kumimoji="1" lang="ja-JP" altLang="en-US" smtClean="0"/>
              <a:t>2024/8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28B31B-A185-46BB-B3AA-6902024757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441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0819105-7C0D-AB7C-19DB-80B72030E36E}"/>
              </a:ext>
            </a:extLst>
          </p:cNvPr>
          <p:cNvSpPr txBox="1"/>
          <p:nvPr/>
        </p:nvSpPr>
        <p:spPr>
          <a:xfrm>
            <a:off x="1074270" y="1106998"/>
            <a:ext cx="5461444" cy="3385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2,286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mechanically ventilated patients with COVID-19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40D6E99-FA23-1EAE-AD29-6E6D9AC4FFD4}"/>
              </a:ext>
            </a:extLst>
          </p:cNvPr>
          <p:cNvSpPr txBox="1"/>
          <p:nvPr/>
        </p:nvSpPr>
        <p:spPr>
          <a:xfrm>
            <a:off x="2418537" y="5645398"/>
            <a:ext cx="2760268" cy="3385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8,327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Analyzed patients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7175DB4-F9F4-FC6C-E63E-4F2E4B360C46}"/>
              </a:ext>
            </a:extLst>
          </p:cNvPr>
          <p:cNvSpPr txBox="1"/>
          <p:nvPr/>
        </p:nvSpPr>
        <p:spPr>
          <a:xfrm>
            <a:off x="4944280" y="4335733"/>
            <a:ext cx="3781021" cy="8309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2,962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With any missing values</a:t>
            </a:r>
          </a:p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338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Transferred in acute phase</a:t>
            </a:r>
          </a:p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2,624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Other missing data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FD0751B-7988-0509-8CA7-04A6F7636766}"/>
              </a:ext>
            </a:extLst>
          </p:cNvPr>
          <p:cNvSpPr txBox="1"/>
          <p:nvPr/>
        </p:nvSpPr>
        <p:spPr>
          <a:xfrm>
            <a:off x="4779100" y="1861051"/>
            <a:ext cx="4108322" cy="132343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997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Excluded</a:t>
            </a:r>
          </a:p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 &lt; 18 years old</a:t>
            </a:r>
          </a:p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845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registered outside the study period</a:t>
            </a:r>
          </a:p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Discrepancy between the start and end dates of mechanical ventilation</a:t>
            </a: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63F11E73-64C3-43C9-F31B-4EFB2A7CB3E2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 flipH="1">
            <a:off x="3798671" y="1445552"/>
            <a:ext cx="6321" cy="419984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DC21F372-0BAA-A787-AE2F-6800827AABB2}"/>
              </a:ext>
            </a:extLst>
          </p:cNvPr>
          <p:cNvCxnSpPr>
            <a:cxnSpLocks/>
            <a:stCxn id="11" idx="1"/>
          </p:cNvCxnSpPr>
          <p:nvPr/>
        </p:nvCxnSpPr>
        <p:spPr>
          <a:xfrm flipH="1">
            <a:off x="3793714" y="2522771"/>
            <a:ext cx="98538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93BA05A-6520-3B25-5F82-CA9290ADE48E}"/>
              </a:ext>
            </a:extLst>
          </p:cNvPr>
          <p:cNvSpPr txBox="1"/>
          <p:nvPr/>
        </p:nvSpPr>
        <p:spPr>
          <a:xfrm>
            <a:off x="2413415" y="3699363"/>
            <a:ext cx="2760269" cy="338554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11,289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Eligible Patients</a:t>
            </a: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3DCC12D8-422A-CD6F-E351-6CAFC6FE970C}"/>
              </a:ext>
            </a:extLst>
          </p:cNvPr>
          <p:cNvCxnSpPr>
            <a:cxnSpLocks/>
            <a:stCxn id="10" idx="1"/>
          </p:cNvCxnSpPr>
          <p:nvPr/>
        </p:nvCxnSpPr>
        <p:spPr>
          <a:xfrm flipH="1">
            <a:off x="3804992" y="4751232"/>
            <a:ext cx="1139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06AEC8E-5647-AC9A-1495-842A7E5D3293}"/>
              </a:ext>
            </a:extLst>
          </p:cNvPr>
          <p:cNvSpPr txBox="1"/>
          <p:nvPr/>
        </p:nvSpPr>
        <p:spPr>
          <a:xfrm>
            <a:off x="633846" y="363682"/>
            <a:ext cx="26772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5002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424</TotalTime>
  <Words>53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谷 知也</dc:creator>
  <cp:lastModifiedBy>知也 菊谷</cp:lastModifiedBy>
  <cp:revision>34</cp:revision>
  <dcterms:created xsi:type="dcterms:W3CDTF">2023-09-04T13:47:00Z</dcterms:created>
  <dcterms:modified xsi:type="dcterms:W3CDTF">2024-08-18T07:11:32Z</dcterms:modified>
</cp:coreProperties>
</file>